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88" r:id="rId2"/>
    <p:sldId id="273" r:id="rId3"/>
    <p:sldId id="278" r:id="rId4"/>
    <p:sldId id="258" r:id="rId5"/>
    <p:sldId id="287" r:id="rId6"/>
    <p:sldId id="259" r:id="rId7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C2FFA5D-87B4-456A-9821-1D502468CF0F}" styleName="Stile con tema 1 - Colore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775DCB02-9BB8-47FD-8907-85C794F793BA}" styleName="Stile con tema 1 - Colore 4">
    <a:tblBg>
      <a:fillRef idx="2">
        <a:schemeClr val="accent4"/>
      </a:fillRef>
      <a:effectRef idx="1">
        <a:schemeClr val="accent4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Ref idx="1">
              <a:schemeClr val="accent4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</a:tcBdr>
        <a:fill>
          <a:solidFill>
            <a:schemeClr val="accent4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4"/>
            </a:lnRef>
          </a:left>
          <a:right>
            <a:lnRef idx="2">
              <a:schemeClr val="accent4"/>
            </a:lnRef>
          </a:right>
          <a:top>
            <a:lnRef idx="1">
              <a:schemeClr val="accent4"/>
            </a:lnRef>
          </a:top>
          <a:bottom>
            <a:lnRef idx="1">
              <a:schemeClr val="accent4"/>
            </a:lnRef>
          </a:bottom>
          <a:insideH>
            <a:lnRef idx="1">
              <a:schemeClr val="accent4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2">
              <a:schemeClr val="accent4"/>
            </a:lnRef>
          </a:top>
          <a:bottom>
            <a:lnRef idx="2">
              <a:schemeClr val="accent4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4"/>
            </a:lnRef>
          </a:left>
          <a:right>
            <a:lnRef idx="1">
              <a:schemeClr val="accent4"/>
            </a:lnRef>
          </a:right>
          <a:top>
            <a:lnRef idx="1">
              <a:schemeClr val="accent4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1" autoAdjust="0"/>
    <p:restoredTop sz="93508" autoAdjust="0"/>
  </p:normalViewPr>
  <p:slideViewPr>
    <p:cSldViewPr snapToGrid="0">
      <p:cViewPr varScale="1">
        <p:scale>
          <a:sx n="107" d="100"/>
          <a:sy n="107" d="100"/>
        </p:scale>
        <p:origin x="80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F0D295-7FDA-4FA2-9F99-09CAA7052CC9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A7C6B6-45BC-45CC-991C-4266407F7567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23992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53628F5-CB6F-2F89-46CF-2311CFB98E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C380039-E67C-4710-DFBA-5B872530C8A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FB42BED-9D24-AC64-4B5E-280E7A0A2C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DF88C3-0D21-EC34-90C2-2303BFD780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D64B5F6-6B73-346B-CF1E-B690B6D4E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387990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67D6C4-2620-57FD-6A49-FC2F898957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71ECF68-5030-610A-3A5F-3748F2E5DE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F1FE9E4-E506-0D2F-DE3E-9FA169F4D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115EF9-E88B-0BC1-83E7-7343F2AC31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B6B8547-09DF-51ED-ECA5-86E0CAB113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64326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DBF9043D-7723-E387-5AA4-A4910AFD05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6C20D0A-DCCD-4708-D935-1A4E837D87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858AEEF-51E8-C5D3-704F-082B054AC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2189D7A-B725-E160-8EE4-A08EDF8438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1CCB951-C9DE-5A44-6EF0-88BD186446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2140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B105257-13E8-0463-5769-0E6121DEE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54ACE11-28D2-02C8-044A-1772D5361CA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929A66A-BD17-EABB-F44F-C47C64D20C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026966A-3E7A-E15C-21FB-521B9106E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3DADF67-03D7-D36B-47CB-B96D57E78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3745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93F2F3D-B761-9C0D-5C60-9FD6857864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4A4CAE9-BFF1-F904-FFC5-E668F9B4D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4C5C548-C2C0-A186-D9F8-FD5654612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06FA47C-1E97-A3A5-C9E6-6FF68DE3FF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46F2755-2731-1480-1B12-C5F504EC7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8358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4B050C5-6A1A-5B5A-03D3-747A173DCD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61A9A6A7-2515-FFD5-9E2B-C3DB767A64F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1CB34CE-3A81-EB76-439E-8D626847B9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9149E99-658A-2683-7A32-8D9D320336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B14E907-AD24-2B2E-A1EC-5F7C9CCAD1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7FA6172-B04B-48A6-79FC-46DBFDA3E7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4306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C0903FE-39EA-34C2-0453-985685DEAC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AB31DE1-98D5-FFBE-6B78-8D4C7DEE94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8EC0AAA-6D20-8E50-221E-78DB1AA4F5E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5D56FBA-495D-DD16-B8B7-E28ED4B535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396F1080-9552-8283-1666-5A891B198F8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B1D205AE-A890-F576-56A1-A17A5B804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75F47288-4F4D-4A98-7230-4B1884B35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6FA3ABA7-504C-9EBC-EC44-83A9A4E96C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6415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69B1690-A059-2DE2-3E6D-2670B7893C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F515CD4-E9E3-AF2E-215D-4B7B432E98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7EFA929-71CF-8BEC-48C7-2D4BB0132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BDCD11A-A0DD-1DF7-731D-EA43F5FE1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79216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48E1FF6D-883D-6C1C-BE61-F67E6B1F58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5CC0A64-3083-DB93-D574-7DC5B6DBC1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CA869C4-B50B-E32F-06ED-4FB7C8388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43980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206EA82-DF7B-30B9-ECAE-CECAF684EA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9611FD0-FEB0-742E-1CEC-73E55858AE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BAB4895-91B9-03BF-94CB-7853BCDF03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693E947-0CF5-4EE4-7983-DC68653D4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859BF72-377A-A8E1-4FAF-EB260BE33A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ADD4CF7-219E-C288-856E-ED1AE1616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97587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002E2D4-8CC1-422D-2909-F1F7623070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13170C4C-40E8-8458-358C-E7CE9EEF5D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38183AC1-67C7-1CCE-728E-2AE7195C8B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192040C-EA5D-6E30-E923-E414B79D4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975F56E-3A24-4B46-E7D0-A84C1D59AA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90AD86C-0076-A5DD-C2D6-DF7C6A7A9D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92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7D2E3EAF-37A0-2CC1-35AA-FE6E98D965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39957CF-A0DF-948C-AEF3-26C7F20B17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845617-A721-02ED-49E9-BB9B853541F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BAA6176-10C3-443A-9BCE-893EFE88E874}" type="datetimeFigureOut">
              <a:rPr lang="it-IT" smtClean="0"/>
              <a:t>22/01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3CCFE3C-5DDC-0693-D695-ACBA2B0E3B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BDB74C1-47E0-0D63-E7AE-8F0AE7F71C4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F4605B-B2BA-4451-ADF5-2CD2694B9896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0999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4.emf"/><Relationship Id="rId7" Type="http://schemas.openxmlformats.org/officeDocument/2006/relationships/image" Target="../media/image7.png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emf"/><Relationship Id="rId4" Type="http://schemas.openxmlformats.org/officeDocument/2006/relationships/oleObject" Target="../embeddings/oleObject3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image" Target="../media/image9.emf"/><Relationship Id="rId7" Type="http://schemas.openxmlformats.org/officeDocument/2006/relationships/image" Target="../media/image12.png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emf"/><Relationship Id="rId4" Type="http://schemas.openxmlformats.org/officeDocument/2006/relationships/oleObject" Target="../embeddings/oleObject5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4.emf"/><Relationship Id="rId7" Type="http://schemas.openxmlformats.org/officeDocument/2006/relationships/image" Target="../media/image17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5" Type="http://schemas.openxmlformats.org/officeDocument/2006/relationships/image" Target="../media/image16.png"/><Relationship Id="rId4" Type="http://schemas.openxmlformats.org/officeDocument/2006/relationships/image" Target="../media/image15.png"/><Relationship Id="rId9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table with numbers and symbols&#10;&#10;Description automatically generated">
            <a:extLst>
              <a:ext uri="{FF2B5EF4-FFF2-40B4-BE49-F238E27FC236}">
                <a16:creationId xmlns:a16="http://schemas.microsoft.com/office/drawing/2014/main" id="{A4F06B80-1D09-D9D4-8182-BC75B637DD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43456" y="1097281"/>
            <a:ext cx="7778496" cy="3288982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506E068-9925-0BD1-6C45-CA138526D9B9}"/>
              </a:ext>
            </a:extLst>
          </p:cNvPr>
          <p:cNvSpPr txBox="1"/>
          <p:nvPr/>
        </p:nvSpPr>
        <p:spPr>
          <a:xfrm>
            <a:off x="1743456" y="4386263"/>
            <a:ext cx="773301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 err="1"/>
              <a:t>Histone</a:t>
            </a:r>
            <a:r>
              <a:rPr lang="it-IT" dirty="0"/>
              <a:t> H3 D1H2 XP 		         4499	         Cell </a:t>
            </a:r>
            <a:r>
              <a:rPr lang="it-IT" dirty="0" err="1"/>
              <a:t>Signaling</a:t>
            </a:r>
            <a:r>
              <a:rPr lang="it-IT" dirty="0"/>
              <a:t> Technology</a:t>
            </a:r>
          </a:p>
          <a:p>
            <a:r>
              <a:rPr lang="it-IT" dirty="0" err="1"/>
              <a:t>Try-Methyl-Histone</a:t>
            </a:r>
            <a:r>
              <a:rPr lang="it-IT" dirty="0"/>
              <a:t> H3 Lys 27                           9733          Cell </a:t>
            </a:r>
            <a:r>
              <a:rPr lang="it-IT" dirty="0" err="1"/>
              <a:t>Signaling</a:t>
            </a:r>
            <a:r>
              <a:rPr lang="it-IT" dirty="0"/>
              <a:t> Technology</a:t>
            </a:r>
          </a:p>
          <a:p>
            <a:r>
              <a:rPr lang="it-IT" dirty="0"/>
              <a:t>Anti-ABCC9 </a:t>
            </a:r>
            <a:r>
              <a:rPr lang="it-IT" dirty="0" err="1"/>
              <a:t>antibody</a:t>
            </a:r>
            <a:r>
              <a:rPr lang="it-IT" dirty="0"/>
              <a:t>                                ab174629           </a:t>
            </a:r>
            <a:r>
              <a:rPr lang="it-IT" dirty="0" err="1"/>
              <a:t>Abcam</a:t>
            </a:r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3CE4A68-A9B1-9FD4-32BB-C4439788AECB}"/>
              </a:ext>
            </a:extLst>
          </p:cNvPr>
          <p:cNvSpPr txBox="1"/>
          <p:nvPr/>
        </p:nvSpPr>
        <p:spPr>
          <a:xfrm>
            <a:off x="1934777" y="5576053"/>
            <a:ext cx="44525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i="1" dirty="0">
                <a:latin typeface="Palatino Linotype" panose="02040502050505030304" pitchFamily="18" charset="0"/>
              </a:rPr>
              <a:t>Table S1 </a:t>
            </a:r>
            <a:r>
              <a:rPr lang="it-IT" dirty="0">
                <a:latin typeface="Palatino Linotype" panose="02040502050505030304" pitchFamily="18" charset="0"/>
              </a:rPr>
              <a:t>Antibody list for western blotting</a:t>
            </a:r>
            <a:endParaRPr lang="en-US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12365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po 8">
            <a:extLst>
              <a:ext uri="{FF2B5EF4-FFF2-40B4-BE49-F238E27FC236}">
                <a16:creationId xmlns:a16="http://schemas.microsoft.com/office/drawing/2014/main" id="{31FA60B1-0B41-FD32-127F-506B5084E58B}"/>
              </a:ext>
            </a:extLst>
          </p:cNvPr>
          <p:cNvGrpSpPr/>
          <p:nvPr/>
        </p:nvGrpSpPr>
        <p:grpSpPr>
          <a:xfrm>
            <a:off x="3124611" y="16373"/>
            <a:ext cx="5256362" cy="5354768"/>
            <a:chOff x="3157268" y="643466"/>
            <a:chExt cx="4837202" cy="4747777"/>
          </a:xfrm>
        </p:grpSpPr>
        <p:pic>
          <p:nvPicPr>
            <p:cNvPr id="4" name="Immagine 3" descr="A screenshot of a graph&#10;&#10;Description automatically generated">
              <a:extLst>
                <a:ext uri="{FF2B5EF4-FFF2-40B4-BE49-F238E27FC236}">
                  <a16:creationId xmlns:a16="http://schemas.microsoft.com/office/drawing/2014/main" id="{16E451F4-F973-A27E-1928-EE4194A629C3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00998" y="643466"/>
              <a:ext cx="4593472" cy="4747777"/>
            </a:xfrm>
            <a:prstGeom prst="rect">
              <a:avLst/>
            </a:prstGeom>
          </p:spPr>
        </p:pic>
        <p:grpSp>
          <p:nvGrpSpPr>
            <p:cNvPr id="8" name="Gruppo 7">
              <a:extLst>
                <a:ext uri="{FF2B5EF4-FFF2-40B4-BE49-F238E27FC236}">
                  <a16:creationId xmlns:a16="http://schemas.microsoft.com/office/drawing/2014/main" id="{8C2FCAF3-35A3-8552-3DFC-11B804D88608}"/>
                </a:ext>
              </a:extLst>
            </p:cNvPr>
            <p:cNvGrpSpPr/>
            <p:nvPr/>
          </p:nvGrpSpPr>
          <p:grpSpPr>
            <a:xfrm>
              <a:off x="3157268" y="852391"/>
              <a:ext cx="370563" cy="3295995"/>
              <a:chOff x="3157268" y="852391"/>
              <a:chExt cx="370563" cy="3295995"/>
            </a:xfrm>
          </p:grpSpPr>
          <p:sp>
            <p:nvSpPr>
              <p:cNvPr id="5" name="CasellaDiTesto 4">
                <a:extLst>
                  <a:ext uri="{FF2B5EF4-FFF2-40B4-BE49-F238E27FC236}">
                    <a16:creationId xmlns:a16="http://schemas.microsoft.com/office/drawing/2014/main" id="{485EE429-72D8-7319-1015-3093FDBFE0B3}"/>
                  </a:ext>
                </a:extLst>
              </p:cNvPr>
              <p:cNvSpPr txBox="1"/>
              <p:nvPr/>
            </p:nvSpPr>
            <p:spPr>
              <a:xfrm>
                <a:off x="3157268" y="3875497"/>
                <a:ext cx="370563" cy="27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>
                    <a:cs typeface="Arial" panose="020B0604020202020204" pitchFamily="34" charset="0"/>
                  </a:rPr>
                  <a:t>(c)</a:t>
                </a:r>
              </a:p>
            </p:txBody>
          </p:sp>
          <p:sp>
            <p:nvSpPr>
              <p:cNvPr id="6" name="CasellaDiTesto 5">
                <a:extLst>
                  <a:ext uri="{FF2B5EF4-FFF2-40B4-BE49-F238E27FC236}">
                    <a16:creationId xmlns:a16="http://schemas.microsoft.com/office/drawing/2014/main" id="{AAC3B6BD-D73E-DF0B-281D-1C06508E5A79}"/>
                  </a:ext>
                </a:extLst>
              </p:cNvPr>
              <p:cNvSpPr txBox="1"/>
              <p:nvPr/>
            </p:nvSpPr>
            <p:spPr>
              <a:xfrm>
                <a:off x="3157268" y="2359751"/>
                <a:ext cx="364662" cy="27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>
                    <a:cs typeface="Arial" panose="020B0604020202020204" pitchFamily="34" charset="0"/>
                  </a:rPr>
                  <a:t>(b)</a:t>
                </a:r>
              </a:p>
            </p:txBody>
          </p:sp>
          <p:sp>
            <p:nvSpPr>
              <p:cNvPr id="7" name="CasellaDiTesto 6">
                <a:extLst>
                  <a:ext uri="{FF2B5EF4-FFF2-40B4-BE49-F238E27FC236}">
                    <a16:creationId xmlns:a16="http://schemas.microsoft.com/office/drawing/2014/main" id="{CB570F86-E09D-1615-A6EE-ACCD970314FB}"/>
                  </a:ext>
                </a:extLst>
              </p:cNvPr>
              <p:cNvSpPr txBox="1"/>
              <p:nvPr/>
            </p:nvSpPr>
            <p:spPr>
              <a:xfrm>
                <a:off x="3157268" y="852391"/>
                <a:ext cx="370563" cy="27288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b="1" dirty="0">
                    <a:cs typeface="Arial" panose="020B0604020202020204" pitchFamily="34" charset="0"/>
                  </a:rPr>
                  <a:t>(a)</a:t>
                </a:r>
              </a:p>
            </p:txBody>
          </p:sp>
        </p:grp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7DAE467F-D200-6322-449E-04C39175BDCF}"/>
              </a:ext>
            </a:extLst>
          </p:cNvPr>
          <p:cNvSpPr txBox="1"/>
          <p:nvPr/>
        </p:nvSpPr>
        <p:spPr>
          <a:xfrm>
            <a:off x="3124611" y="123111"/>
            <a:ext cx="348172" cy="3970318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r>
              <a:rPr lang="it-IT" b="1" dirty="0"/>
              <a:t>B</a:t>
            </a:r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endParaRPr lang="it-IT" b="1" dirty="0"/>
          </a:p>
          <a:p>
            <a:r>
              <a:rPr lang="it-IT" b="1" dirty="0"/>
              <a:t>C</a:t>
            </a:r>
            <a:endParaRPr lang="en-US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3435943-589C-3E4A-BAF2-85BAAF74DA89}"/>
              </a:ext>
            </a:extLst>
          </p:cNvPr>
          <p:cNvSpPr txBox="1"/>
          <p:nvPr/>
        </p:nvSpPr>
        <p:spPr>
          <a:xfrm>
            <a:off x="6719836" y="0"/>
            <a:ext cx="1008609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it-IT" sz="1000" b="1" dirty="0"/>
              <a:t>REPA (200 </a:t>
            </a:r>
            <a:r>
              <a:rPr lang="it-IT" sz="1000" b="1" dirty="0" err="1">
                <a:latin typeface="Symbol" panose="05050102010706020507" pitchFamily="18" charset="2"/>
              </a:rPr>
              <a:t>m</a:t>
            </a:r>
            <a:r>
              <a:rPr lang="it-IT" sz="1000" b="1" dirty="0" err="1"/>
              <a:t>M</a:t>
            </a:r>
            <a:r>
              <a:rPr lang="it-IT" sz="1000" b="1" dirty="0"/>
              <a:t>)</a:t>
            </a:r>
            <a:endParaRPr lang="en-US" sz="1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7C5A47F-D1C9-C087-5E9C-37DDBE2A4A5F}"/>
              </a:ext>
            </a:extLst>
          </p:cNvPr>
          <p:cNvSpPr txBox="1"/>
          <p:nvPr/>
        </p:nvSpPr>
        <p:spPr>
          <a:xfrm>
            <a:off x="272456" y="5485724"/>
            <a:ext cx="10428201" cy="7063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ffects of repaglinide (REPA) on cell diameter in control vs treated DIPG-50 cells after 6-72 h of incubation times. Gaussian type distribution of DIPG-50 cells as a function of cell diameter size after 6 h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48 h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72 h </a:t>
            </a:r>
            <a:r>
              <a:rPr lang="en-US" sz="1400" b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C)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of incubation times.</a:t>
            </a:r>
            <a:r>
              <a:rPr lang="en-US" sz="1400" i="1" kern="1200" dirty="0">
                <a:effectLst/>
                <a:latin typeface="Calibri" panose="020F0502020204030204" pitchFamily="34" charset="0"/>
                <a:ea typeface="DengXian" panose="02010600030101010101" pitchFamily="2" charset="-122"/>
                <a:cs typeface="Arial" panose="020B0604020202020204" pitchFamily="34" charset="0"/>
              </a:rPr>
              <a:t> </a:t>
            </a:r>
            <a:endParaRPr lang="en-US" sz="1400" dirty="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51056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Oggetto 3">
            <a:extLst>
              <a:ext uri="{FF2B5EF4-FFF2-40B4-BE49-F238E27FC236}">
                <a16:creationId xmlns:a16="http://schemas.microsoft.com/office/drawing/2014/main" id="{B28F7A95-F8A2-6F7C-6D37-97762CB2606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10805" y="747558"/>
          <a:ext cx="4570389" cy="36763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592611" imgH="3517498" progId="Prism8.Document">
                  <p:embed/>
                </p:oleObj>
              </mc:Choice>
              <mc:Fallback>
                <p:oleObj name="Prism 8" r:id="rId2" imgW="3592611" imgH="3517498" progId="Prism8.Document">
                  <p:embed/>
                  <p:pic>
                    <p:nvPicPr>
                      <p:cNvPr id="17" name="Oggetto 3">
                        <a:extLst>
                          <a:ext uri="{FF2B5EF4-FFF2-40B4-BE49-F238E27FC236}">
                            <a16:creationId xmlns:a16="http://schemas.microsoft.com/office/drawing/2014/main" id="{B28F7A95-F8A2-6F7C-6D37-97762CB2606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810805" y="747558"/>
                        <a:ext cx="4570389" cy="36763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00445DDA-A18D-52AC-C5FC-E2C3E8108367}"/>
              </a:ext>
            </a:extLst>
          </p:cNvPr>
          <p:cNvSpPr txBox="1"/>
          <p:nvPr/>
        </p:nvSpPr>
        <p:spPr>
          <a:xfrm>
            <a:off x="946935" y="4705708"/>
            <a:ext cx="10428201" cy="5016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ffects of increasing concentration of </a:t>
            </a:r>
            <a:r>
              <a:rPr lang="en-US" sz="1400" dirty="0" err="1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libenclamide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GLIB) and repaglinide (REPA) on cell survivals treated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rine bone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arrow cells vs controls after 72 h of incubation times. </a:t>
            </a:r>
          </a:p>
        </p:txBody>
      </p:sp>
    </p:spTree>
    <p:extLst>
      <p:ext uri="{BB962C8B-B14F-4D97-AF65-F5344CB8AC3E}">
        <p14:creationId xmlns:p14="http://schemas.microsoft.com/office/powerpoint/2010/main" val="30190824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po 30">
            <a:extLst>
              <a:ext uri="{FF2B5EF4-FFF2-40B4-BE49-F238E27FC236}">
                <a16:creationId xmlns:a16="http://schemas.microsoft.com/office/drawing/2014/main" id="{B6E96953-F4F6-4A07-A63E-C68A42D4E74F}"/>
              </a:ext>
            </a:extLst>
          </p:cNvPr>
          <p:cNvGrpSpPr/>
          <p:nvPr/>
        </p:nvGrpSpPr>
        <p:grpSpPr>
          <a:xfrm>
            <a:off x="192088" y="608013"/>
            <a:ext cx="8666162" cy="3716337"/>
            <a:chOff x="309533" y="-161468"/>
            <a:chExt cx="8666162" cy="3716337"/>
          </a:xfrm>
        </p:grpSpPr>
        <p:graphicFrame>
          <p:nvGraphicFramePr>
            <p:cNvPr id="13" name="Oggetto 12">
              <a:extLst>
                <a:ext uri="{FF2B5EF4-FFF2-40B4-BE49-F238E27FC236}">
                  <a16:creationId xmlns:a16="http://schemas.microsoft.com/office/drawing/2014/main" id="{B66FC666-16A8-4A02-81A2-36FFF71B3306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09533" y="46494"/>
            <a:ext cx="4017962" cy="34925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" imgW="3402219" imgH="2958068" progId="Prism8.Document">
                    <p:embed/>
                  </p:oleObj>
                </mc:Choice>
                <mc:Fallback>
                  <p:oleObj name="Prism 8" r:id="rId2" imgW="3402219" imgH="2958068" progId="Prism8.Document">
                    <p:embed/>
                    <p:pic>
                      <p:nvPicPr>
                        <p:cNvPr id="13" name="Oggetto 12">
                          <a:extLst>
                            <a:ext uri="{FF2B5EF4-FFF2-40B4-BE49-F238E27FC236}">
                              <a16:creationId xmlns:a16="http://schemas.microsoft.com/office/drawing/2014/main" id="{B66FC666-16A8-4A02-81A2-36FFF71B330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09533" y="46494"/>
                          <a:ext cx="4017962" cy="34925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1" name="Oggetto 20">
              <a:extLst>
                <a:ext uri="{FF2B5EF4-FFF2-40B4-BE49-F238E27FC236}">
                  <a16:creationId xmlns:a16="http://schemas.microsoft.com/office/drawing/2014/main" id="{54B60988-0300-4F1F-A276-0D9A0FE6234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5227608" y="-161468"/>
            <a:ext cx="3748087" cy="37163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" imgW="3400779" imgH="3368101" progId="Prism8.Document">
                    <p:embed/>
                  </p:oleObj>
                </mc:Choice>
                <mc:Fallback>
                  <p:oleObj name="Prism 8" r:id="rId4" imgW="3400779" imgH="3368101" progId="Prism8.Document">
                    <p:embed/>
                    <p:pic>
                      <p:nvPicPr>
                        <p:cNvPr id="21" name="Oggetto 20">
                          <a:extLst>
                            <a:ext uri="{FF2B5EF4-FFF2-40B4-BE49-F238E27FC236}">
                              <a16:creationId xmlns:a16="http://schemas.microsoft.com/office/drawing/2014/main" id="{54B60988-0300-4F1F-A276-0D9A0FE6234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5227608" y="-161468"/>
                          <a:ext cx="3748087" cy="37163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30" name="Gruppo 29">
            <a:extLst>
              <a:ext uri="{FF2B5EF4-FFF2-40B4-BE49-F238E27FC236}">
                <a16:creationId xmlns:a16="http://schemas.microsoft.com/office/drawing/2014/main" id="{7A128CE8-E1B4-4EBC-83A3-646E204DC4A4}"/>
              </a:ext>
            </a:extLst>
          </p:cNvPr>
          <p:cNvGrpSpPr/>
          <p:nvPr/>
        </p:nvGrpSpPr>
        <p:grpSpPr>
          <a:xfrm>
            <a:off x="546571" y="4419662"/>
            <a:ext cx="6098874" cy="1777724"/>
            <a:chOff x="546571" y="4419662"/>
            <a:chExt cx="6098874" cy="1777724"/>
          </a:xfrm>
        </p:grpSpPr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C41C79E9-85BB-44F8-9A16-85C351A30EA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93668" y="4419662"/>
              <a:ext cx="2384644" cy="545739"/>
            </a:xfrm>
            <a:prstGeom prst="rect">
              <a:avLst/>
            </a:prstGeom>
          </p:spPr>
        </p:pic>
        <p:pic>
          <p:nvPicPr>
            <p:cNvPr id="20" name="Immagine 19">
              <a:extLst>
                <a:ext uri="{FF2B5EF4-FFF2-40B4-BE49-F238E27FC236}">
                  <a16:creationId xmlns:a16="http://schemas.microsoft.com/office/drawing/2014/main" id="{F84E5D48-639E-40A7-A590-A8F1F7279E0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593669" y="5621782"/>
              <a:ext cx="2384644" cy="575604"/>
            </a:xfrm>
            <a:prstGeom prst="rect">
              <a:avLst/>
            </a:prstGeom>
          </p:spPr>
        </p:pic>
        <p:sp>
          <p:nvSpPr>
            <p:cNvPr id="25" name="CasellaDiTesto 24">
              <a:extLst>
                <a:ext uri="{FF2B5EF4-FFF2-40B4-BE49-F238E27FC236}">
                  <a16:creationId xmlns:a16="http://schemas.microsoft.com/office/drawing/2014/main" id="{D85A3808-86B2-429B-B473-7F86A812B985}"/>
                </a:ext>
              </a:extLst>
            </p:cNvPr>
            <p:cNvSpPr txBox="1"/>
            <p:nvPr/>
          </p:nvSpPr>
          <p:spPr>
            <a:xfrm>
              <a:off x="546571" y="5146080"/>
              <a:ext cx="609887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b="1" dirty="0"/>
                <a:t>Tri-</a:t>
              </a:r>
              <a:r>
                <a:rPr lang="it-IT" b="1" dirty="0" err="1"/>
                <a:t>Methyl</a:t>
              </a:r>
              <a:r>
                <a:rPr lang="it-IT" b="1" dirty="0"/>
                <a:t> H3(Lys27) </a:t>
              </a:r>
            </a:p>
          </p:txBody>
        </p:sp>
        <p:pic>
          <p:nvPicPr>
            <p:cNvPr id="27" name="Immagine 26">
              <a:extLst>
                <a:ext uri="{FF2B5EF4-FFF2-40B4-BE49-F238E27FC236}">
                  <a16:creationId xmlns:a16="http://schemas.microsoft.com/office/drawing/2014/main" id="{1A9390B0-87A9-4D57-8A90-19A099B5D7E8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800932" y="5046860"/>
              <a:ext cx="2384644" cy="567772"/>
            </a:xfrm>
            <a:prstGeom prst="rect">
              <a:avLst/>
            </a:prstGeom>
          </p:spPr>
        </p:pic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3FC852CE-5CE0-4834-8FCE-1BC959C85BAA}"/>
                </a:ext>
              </a:extLst>
            </p:cNvPr>
            <p:cNvSpPr txBox="1"/>
            <p:nvPr/>
          </p:nvSpPr>
          <p:spPr>
            <a:xfrm>
              <a:off x="546571" y="4521495"/>
              <a:ext cx="609887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b="1" dirty="0" err="1"/>
                <a:t>Histone</a:t>
              </a:r>
              <a:r>
                <a:rPr lang="it-IT" b="1" dirty="0"/>
                <a:t> H3  </a:t>
              </a:r>
            </a:p>
          </p:txBody>
        </p:sp>
        <p:sp>
          <p:nvSpPr>
            <p:cNvPr id="29" name="CasellaDiTesto 28">
              <a:extLst>
                <a:ext uri="{FF2B5EF4-FFF2-40B4-BE49-F238E27FC236}">
                  <a16:creationId xmlns:a16="http://schemas.microsoft.com/office/drawing/2014/main" id="{1615F103-8CD4-4302-AABF-68E1AF1E7855}"/>
                </a:ext>
              </a:extLst>
            </p:cNvPr>
            <p:cNvSpPr txBox="1"/>
            <p:nvPr/>
          </p:nvSpPr>
          <p:spPr>
            <a:xfrm>
              <a:off x="546571" y="5713852"/>
              <a:ext cx="609887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b="1" dirty="0"/>
                <a:t>β</a:t>
              </a:r>
              <a:r>
                <a:rPr lang="it-IT" b="1" dirty="0"/>
                <a:t>-</a:t>
              </a:r>
              <a:r>
                <a:rPr lang="it-IT" b="1" dirty="0" err="1"/>
                <a:t>actin</a:t>
              </a:r>
              <a:endParaRPr lang="it-IT" b="1" dirty="0"/>
            </a:p>
          </p:txBody>
        </p:sp>
      </p:grp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3D2EA09B-2AD4-4652-B587-25F3A51EE7B7}"/>
              </a:ext>
            </a:extLst>
          </p:cNvPr>
          <p:cNvSpPr txBox="1"/>
          <p:nvPr/>
        </p:nvSpPr>
        <p:spPr>
          <a:xfrm>
            <a:off x="92278" y="131372"/>
            <a:ext cx="132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DIPG-36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C298E82-9763-02C9-B9BE-0E700ECEA89F}"/>
              </a:ext>
            </a:extLst>
          </p:cNvPr>
          <p:cNvSpPr txBox="1"/>
          <p:nvPr/>
        </p:nvSpPr>
        <p:spPr>
          <a:xfrm>
            <a:off x="6181344" y="4705708"/>
            <a:ext cx="5193792" cy="11156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ffects of increasing concentrations of repaglinide (REPA) on Histone H3 and Tri-Methyl H3 (Lys27) in western blotting in DIPG-36 cells after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 of incubation times vs </a:t>
            </a:r>
            <a:r>
              <a:rPr lang="en-US" sz="14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actin. </a:t>
            </a:r>
          </a:p>
        </p:txBody>
      </p:sp>
    </p:spTree>
    <p:extLst>
      <p:ext uri="{BB962C8B-B14F-4D97-AF65-F5344CB8AC3E}">
        <p14:creationId xmlns:p14="http://schemas.microsoft.com/office/powerpoint/2010/main" val="42140823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E2A89EA2-4071-4D2C-AF6A-D5DBFAD967CD}"/>
              </a:ext>
            </a:extLst>
          </p:cNvPr>
          <p:cNvSpPr txBox="1"/>
          <p:nvPr/>
        </p:nvSpPr>
        <p:spPr>
          <a:xfrm>
            <a:off x="117445" y="131372"/>
            <a:ext cx="132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DIPG-50</a:t>
            </a:r>
          </a:p>
        </p:txBody>
      </p:sp>
      <p:graphicFrame>
        <p:nvGraphicFramePr>
          <p:cNvPr id="5" name="Oggetto 4">
            <a:extLst>
              <a:ext uri="{FF2B5EF4-FFF2-40B4-BE49-F238E27FC236}">
                <a16:creationId xmlns:a16="http://schemas.microsoft.com/office/drawing/2014/main" id="{D05F09DD-3A57-4EB5-BDA9-163E7E2B16B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343525" y="455613"/>
          <a:ext cx="3400425" cy="33702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400779" imgH="3369541" progId="Prism8.Document">
                  <p:embed/>
                </p:oleObj>
              </mc:Choice>
              <mc:Fallback>
                <p:oleObj name="Prism 8" r:id="rId2" imgW="3400779" imgH="3369541" progId="Prism8.Document">
                  <p:embed/>
                  <p:pic>
                    <p:nvPicPr>
                      <p:cNvPr id="5" name="Oggetto 4">
                        <a:extLst>
                          <a:ext uri="{FF2B5EF4-FFF2-40B4-BE49-F238E27FC236}">
                            <a16:creationId xmlns:a16="http://schemas.microsoft.com/office/drawing/2014/main" id="{D05F09DD-3A57-4EB5-BDA9-163E7E2B16B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343525" y="455613"/>
                        <a:ext cx="3400425" cy="33702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96181768-B26D-44D5-BE9D-97837D5E113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190625" y="652463"/>
          <a:ext cx="3394075" cy="319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394661" imgH="3194224" progId="Prism8.Document">
                  <p:embed/>
                </p:oleObj>
              </mc:Choice>
              <mc:Fallback>
                <p:oleObj name="Prism 8" r:id="rId4" imgW="3394661" imgH="3194224" progId="Prism8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96181768-B26D-44D5-BE9D-97837D5E113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190625" y="652463"/>
                        <a:ext cx="3394075" cy="319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Immagine 11">
            <a:extLst>
              <a:ext uri="{FF2B5EF4-FFF2-40B4-BE49-F238E27FC236}">
                <a16:creationId xmlns:a16="http://schemas.microsoft.com/office/drawing/2014/main" id="{21FDBA05-D06C-4519-8735-22C89F54B3B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92261" y="4728749"/>
            <a:ext cx="2809434" cy="479255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B397E169-9607-4DAA-84E8-3DD99AB8616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92261" y="5820937"/>
            <a:ext cx="2809434" cy="622710"/>
          </a:xfrm>
          <a:prstGeom prst="rect">
            <a:avLst/>
          </a:prstGeom>
        </p:spPr>
      </p:pic>
      <p:pic>
        <p:nvPicPr>
          <p:cNvPr id="16" name="Immagine 15">
            <a:extLst>
              <a:ext uri="{FF2B5EF4-FFF2-40B4-BE49-F238E27FC236}">
                <a16:creationId xmlns:a16="http://schemas.microsoft.com/office/drawing/2014/main" id="{A30F31A3-D339-4A99-B583-E2B923EF723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642257" y="5312620"/>
            <a:ext cx="2703763" cy="386251"/>
          </a:xfrm>
          <a:prstGeom prst="rect">
            <a:avLst/>
          </a:prstGeom>
        </p:spPr>
      </p:pic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9496AD47-EA13-4007-9CB7-4CE3E104290D}"/>
              </a:ext>
            </a:extLst>
          </p:cNvPr>
          <p:cNvSpPr txBox="1"/>
          <p:nvPr/>
        </p:nvSpPr>
        <p:spPr>
          <a:xfrm>
            <a:off x="513914" y="5353334"/>
            <a:ext cx="6098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/>
              <a:t>Tri-</a:t>
            </a:r>
            <a:r>
              <a:rPr lang="it-IT" b="1" dirty="0" err="1"/>
              <a:t>Methyl</a:t>
            </a:r>
            <a:r>
              <a:rPr lang="it-IT" b="1" dirty="0"/>
              <a:t> H3(Lys27) 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86F4BB90-589C-4303-9D0F-C45B9D5D0F9B}"/>
              </a:ext>
            </a:extLst>
          </p:cNvPr>
          <p:cNvSpPr txBox="1"/>
          <p:nvPr/>
        </p:nvSpPr>
        <p:spPr>
          <a:xfrm>
            <a:off x="513914" y="4728749"/>
            <a:ext cx="6098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b="1" dirty="0" err="1"/>
              <a:t>Histone</a:t>
            </a:r>
            <a:r>
              <a:rPr lang="it-IT" b="1" dirty="0"/>
              <a:t> H3  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AB717C26-4172-4135-8511-851C2274A1FF}"/>
              </a:ext>
            </a:extLst>
          </p:cNvPr>
          <p:cNvSpPr txBox="1"/>
          <p:nvPr/>
        </p:nvSpPr>
        <p:spPr>
          <a:xfrm>
            <a:off x="513914" y="5921106"/>
            <a:ext cx="6098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b="1" dirty="0"/>
              <a:t>β</a:t>
            </a:r>
            <a:r>
              <a:rPr lang="it-IT" b="1" dirty="0"/>
              <a:t>-</a:t>
            </a:r>
            <a:r>
              <a:rPr lang="it-IT" b="1" dirty="0" err="1"/>
              <a:t>actin</a:t>
            </a:r>
            <a:endParaRPr lang="it-IT" b="1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9E5F0F2-C4C4-2ABA-4C5D-552A9010D1C4}"/>
              </a:ext>
            </a:extLst>
          </p:cNvPr>
          <p:cNvSpPr txBox="1"/>
          <p:nvPr/>
        </p:nvSpPr>
        <p:spPr>
          <a:xfrm>
            <a:off x="6144235" y="4237644"/>
            <a:ext cx="5193792" cy="11156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ffects of increasing concentrations of repaglinide (REPA) on Histone H3 and Tri-Methyl H3 (Lys27) in western blotting in DIPG-50 cells after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 of incubation times vs </a:t>
            </a:r>
            <a:r>
              <a:rPr lang="en-US" sz="14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actin. </a:t>
            </a:r>
          </a:p>
        </p:txBody>
      </p:sp>
    </p:spTree>
    <p:extLst>
      <p:ext uri="{BB962C8B-B14F-4D97-AF65-F5344CB8AC3E}">
        <p14:creationId xmlns:p14="http://schemas.microsoft.com/office/powerpoint/2010/main" val="375132349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ggetto 5">
            <a:extLst>
              <a:ext uri="{FF2B5EF4-FFF2-40B4-BE49-F238E27FC236}">
                <a16:creationId xmlns:a16="http://schemas.microsoft.com/office/drawing/2014/main" id="{6E9541D6-A5B6-4CC5-A72A-65B8BB1D6DD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41313" y="819150"/>
          <a:ext cx="3402012" cy="2957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402219" imgH="2958068" progId="Prism8.Document">
                  <p:embed/>
                </p:oleObj>
              </mc:Choice>
              <mc:Fallback>
                <p:oleObj name="Prism 8" r:id="rId2" imgW="3402219" imgH="2958068" progId="Prism8.Document">
                  <p:embed/>
                  <p:pic>
                    <p:nvPicPr>
                      <p:cNvPr id="6" name="Oggetto 5">
                        <a:extLst>
                          <a:ext uri="{FF2B5EF4-FFF2-40B4-BE49-F238E27FC236}">
                            <a16:creationId xmlns:a16="http://schemas.microsoft.com/office/drawing/2014/main" id="{6E9541D6-A5B6-4CC5-A72A-65B8BB1D6D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41313" y="819150"/>
                        <a:ext cx="3402012" cy="2957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7A7BDA1-8CC9-4906-87CB-87B522C653A6}"/>
              </a:ext>
            </a:extLst>
          </p:cNvPr>
          <p:cNvSpPr txBox="1"/>
          <p:nvPr/>
        </p:nvSpPr>
        <p:spPr>
          <a:xfrm>
            <a:off x="92278" y="131372"/>
            <a:ext cx="132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DIPG-36</a:t>
            </a:r>
          </a:p>
        </p:txBody>
      </p:sp>
      <p:grpSp>
        <p:nvGrpSpPr>
          <p:cNvPr id="14" name="Gruppo 13">
            <a:extLst>
              <a:ext uri="{FF2B5EF4-FFF2-40B4-BE49-F238E27FC236}">
                <a16:creationId xmlns:a16="http://schemas.microsoft.com/office/drawing/2014/main" id="{215F68FD-1128-4727-BB34-06E0E5AFC380}"/>
              </a:ext>
            </a:extLst>
          </p:cNvPr>
          <p:cNvGrpSpPr/>
          <p:nvPr/>
        </p:nvGrpSpPr>
        <p:grpSpPr>
          <a:xfrm>
            <a:off x="497827" y="3918376"/>
            <a:ext cx="6098874" cy="1138066"/>
            <a:chOff x="497827" y="3918376"/>
            <a:chExt cx="6098874" cy="1138066"/>
          </a:xfrm>
        </p:grpSpPr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80B4E3A5-6E98-484E-B17E-7F3D3D8864E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334245" y="3918376"/>
              <a:ext cx="1923810" cy="356995"/>
            </a:xfrm>
            <a:prstGeom prst="rect">
              <a:avLst/>
            </a:prstGeom>
          </p:spPr>
        </p:pic>
        <p:pic>
          <p:nvPicPr>
            <p:cNvPr id="10" name="Immagine 9">
              <a:extLst>
                <a:ext uri="{FF2B5EF4-FFF2-40B4-BE49-F238E27FC236}">
                  <a16:creationId xmlns:a16="http://schemas.microsoft.com/office/drawing/2014/main" id="{4591D190-751D-4CF4-97CD-ECFB0CE748D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334245" y="4570728"/>
              <a:ext cx="1923810" cy="485714"/>
            </a:xfrm>
            <a:prstGeom prst="rect">
              <a:avLst/>
            </a:prstGeom>
          </p:spPr>
        </p:pic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73F87ECD-9CC5-4337-B040-1967EBDF7916}"/>
                </a:ext>
              </a:extLst>
            </p:cNvPr>
            <p:cNvSpPr txBox="1"/>
            <p:nvPr/>
          </p:nvSpPr>
          <p:spPr>
            <a:xfrm>
              <a:off x="497827" y="3989950"/>
              <a:ext cx="609887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it-IT" dirty="0"/>
                <a:t>SUR-2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1088AF2A-C5D8-43F8-B66D-A21D447FD3F9}"/>
                </a:ext>
              </a:extLst>
            </p:cNvPr>
            <p:cNvSpPr txBox="1"/>
            <p:nvPr/>
          </p:nvSpPr>
          <p:spPr>
            <a:xfrm>
              <a:off x="497827" y="4661934"/>
              <a:ext cx="609887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l-GR" dirty="0"/>
                <a:t>β</a:t>
              </a:r>
              <a:r>
                <a:rPr lang="it-IT" dirty="0"/>
                <a:t>-</a:t>
              </a:r>
              <a:r>
                <a:rPr lang="it-IT" dirty="0" err="1"/>
                <a:t>actin</a:t>
              </a:r>
              <a:endParaRPr lang="it-IT" dirty="0"/>
            </a:p>
          </p:txBody>
        </p:sp>
      </p:grp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AD6FE2D-9129-40DF-8B5E-5864901D882B}"/>
              </a:ext>
            </a:extLst>
          </p:cNvPr>
          <p:cNvSpPr txBox="1"/>
          <p:nvPr/>
        </p:nvSpPr>
        <p:spPr>
          <a:xfrm>
            <a:off x="6964260" y="131372"/>
            <a:ext cx="13254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b="1" dirty="0"/>
              <a:t>DIPG-50</a:t>
            </a:r>
          </a:p>
        </p:txBody>
      </p:sp>
      <p:graphicFrame>
        <p:nvGraphicFramePr>
          <p:cNvPr id="17" name="Oggetto 16">
            <a:extLst>
              <a:ext uri="{FF2B5EF4-FFF2-40B4-BE49-F238E27FC236}">
                <a16:creationId xmlns:a16="http://schemas.microsoft.com/office/drawing/2014/main" id="{BA5D0FFA-7C6A-4862-9886-8177B91C039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264150" y="671513"/>
          <a:ext cx="3402013" cy="3271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402219" imgH="3271983" progId="Prism8.Document">
                  <p:embed/>
                </p:oleObj>
              </mc:Choice>
              <mc:Fallback>
                <p:oleObj name="Prism 8" r:id="rId6" imgW="3402219" imgH="3271983" progId="Prism8.Document">
                  <p:embed/>
                  <p:pic>
                    <p:nvPicPr>
                      <p:cNvPr id="17" name="Oggetto 16">
                        <a:extLst>
                          <a:ext uri="{FF2B5EF4-FFF2-40B4-BE49-F238E27FC236}">
                            <a16:creationId xmlns:a16="http://schemas.microsoft.com/office/drawing/2014/main" id="{BA5D0FFA-7C6A-4862-9886-8177B91C039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264150" y="671513"/>
                        <a:ext cx="3402013" cy="3271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9" name="Immagine 18">
            <a:extLst>
              <a:ext uri="{FF2B5EF4-FFF2-40B4-BE49-F238E27FC236}">
                <a16:creationId xmlns:a16="http://schemas.microsoft.com/office/drawing/2014/main" id="{83E502E4-4FF9-48E2-8497-8C81C086FAB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30152" y="4068530"/>
            <a:ext cx="2349138" cy="408546"/>
          </a:xfrm>
          <a:prstGeom prst="rect">
            <a:avLst/>
          </a:prstGeom>
        </p:spPr>
      </p:pic>
      <p:pic>
        <p:nvPicPr>
          <p:cNvPr id="21" name="Immagine 20">
            <a:extLst>
              <a:ext uri="{FF2B5EF4-FFF2-40B4-BE49-F238E27FC236}">
                <a16:creationId xmlns:a16="http://schemas.microsoft.com/office/drawing/2014/main" id="{D724BFB2-8FFC-4BBE-B8B1-4083B05F25E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55686" y="4562382"/>
            <a:ext cx="2349138" cy="618859"/>
          </a:xfrm>
          <a:prstGeom prst="rect">
            <a:avLst/>
          </a:prstGeom>
        </p:spPr>
      </p:pic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7C3FD44E-6307-429F-92F3-DD90412CED6B}"/>
              </a:ext>
            </a:extLst>
          </p:cNvPr>
          <p:cNvSpPr txBox="1"/>
          <p:nvPr/>
        </p:nvSpPr>
        <p:spPr>
          <a:xfrm>
            <a:off x="5385513" y="4069196"/>
            <a:ext cx="6098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it-IT" dirty="0"/>
              <a:t>SUR-2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5CAFF37E-B919-4E5E-9D02-94F614605D75}"/>
              </a:ext>
            </a:extLst>
          </p:cNvPr>
          <p:cNvSpPr txBox="1"/>
          <p:nvPr/>
        </p:nvSpPr>
        <p:spPr>
          <a:xfrm>
            <a:off x="5385513" y="4741180"/>
            <a:ext cx="609887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dirty="0"/>
              <a:t>β</a:t>
            </a:r>
            <a:r>
              <a:rPr lang="it-IT" dirty="0"/>
              <a:t>-</a:t>
            </a:r>
            <a:r>
              <a:rPr lang="it-IT" dirty="0" err="1"/>
              <a:t>actin</a:t>
            </a:r>
            <a:endParaRPr lang="it-IT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AF7A602-E0E5-953D-7347-E4AE48E0C55F}"/>
              </a:ext>
            </a:extLst>
          </p:cNvPr>
          <p:cNvSpPr txBox="1"/>
          <p:nvPr/>
        </p:nvSpPr>
        <p:spPr>
          <a:xfrm>
            <a:off x="-1088145" y="5722271"/>
            <a:ext cx="9662939" cy="50167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656080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400" i="1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Effects of increasing concentrations of repaglinide (REPA) on SUR2 in western blotting in DIPG cells after </a:t>
            </a:r>
            <a:r>
              <a:rPr lang="en-US" sz="14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8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 of incubation times vs </a:t>
            </a:r>
            <a:r>
              <a:rPr lang="en-US" sz="1400" dirty="0">
                <a:effectLst/>
                <a:latin typeface="Symbol" panose="05050102010706020507" pitchFamily="18" charset="2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actin. </a:t>
            </a:r>
          </a:p>
        </p:txBody>
      </p:sp>
    </p:spTree>
    <p:extLst>
      <p:ext uri="{BB962C8B-B14F-4D97-AF65-F5344CB8AC3E}">
        <p14:creationId xmlns:p14="http://schemas.microsoft.com/office/powerpoint/2010/main" val="22187770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4</Words>
  <Application>Microsoft Office PowerPoint</Application>
  <PresentationFormat>Widescreen</PresentationFormat>
  <Paragraphs>41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4" baseType="lpstr">
      <vt:lpstr>Aptos</vt:lpstr>
      <vt:lpstr>Aptos Display</vt:lpstr>
      <vt:lpstr>Arial</vt:lpstr>
      <vt:lpstr>Calibri</vt:lpstr>
      <vt:lpstr>Palatino Linotype</vt:lpstr>
      <vt:lpstr>Symbol</vt:lpstr>
      <vt:lpstr>Tema di Office</vt:lpstr>
      <vt:lpstr>Prism 8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nnamaria Di Turi</dc:creator>
  <cp:lastModifiedBy>MDPI</cp:lastModifiedBy>
  <cp:revision>127</cp:revision>
  <dcterms:created xsi:type="dcterms:W3CDTF">2024-05-02T10:17:20Z</dcterms:created>
  <dcterms:modified xsi:type="dcterms:W3CDTF">2025-01-22T10:48:07Z</dcterms:modified>
</cp:coreProperties>
</file>